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46875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22599-D227-4FBF-92FC-4BBABD6699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10F96-7D06-4545-B638-B37F10B227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013E1-62AE-449A-A02B-B3E47F1FA8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56BDF-AA71-49B9-ACEA-428EEF3B39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AB3B1-A1E5-49B1-B0A8-302189B1DE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CB388-B7DA-423E-8330-9E064B0EC5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6AA36-F0C8-4D74-8CDC-D54E01DB67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E72D7-6BD8-4443-B214-46320B10A3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D05D7-4780-46F1-8775-FDDA93D289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F9269-D641-49DA-B498-EDACBA7D4D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1E215-D673-4926-8B3D-00934D35BA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7F32C-B332-4FAA-8DC1-5320525982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1C60F6-314F-438B-A8E0-BCDBAF8D2F7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31800" y="993600"/>
          <a:ext cx="5388120" cy="3230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31800" y="993600"/>
                    <a:ext cx="5388120" cy="323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412920" y="1181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6800" y="4349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3"/>
          <a:stretch/>
        </p:blipFill>
        <p:spPr>
          <a:xfrm>
            <a:off x="623880" y="4162320"/>
            <a:ext cx="5595840" cy="31482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2208960" y="78058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51920" y="3936960"/>
            <a:ext cx="115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pecies cod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0800000">
            <a:off x="488520" y="1747080"/>
            <a:ext cx="362880" cy="129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# domain cop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074040" y="7167600"/>
            <a:ext cx="104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it dist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0800000">
            <a:off x="496440" y="4914360"/>
            <a:ext cx="362880" cy="14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"/>
          <p:cNvGrpSpPr/>
          <p:nvPr/>
        </p:nvGrpSpPr>
        <p:grpSpPr>
          <a:xfrm>
            <a:off x="1295280" y="1403280"/>
            <a:ext cx="1968480" cy="574200"/>
            <a:chOff x="1295280" y="1403280"/>
            <a:chExt cx="1968480" cy="574200"/>
          </a:xfrm>
        </p:grpSpPr>
        <p:grpSp>
          <p:nvGrpSpPr>
            <p:cNvPr id="52" name=""/>
            <p:cNvGrpSpPr/>
            <p:nvPr/>
          </p:nvGrpSpPr>
          <p:grpSpPr>
            <a:xfrm>
              <a:off x="1295280" y="1478160"/>
              <a:ext cx="314640" cy="69840"/>
              <a:chOff x="1295280" y="1478160"/>
              <a:chExt cx="314640" cy="69840"/>
            </a:xfrm>
          </p:grpSpPr>
          <p:sp>
            <p:nvSpPr>
              <p:cNvPr id="53" name=""/>
              <p:cNvSpPr/>
              <p:nvPr/>
            </p:nvSpPr>
            <p:spPr>
              <a:xfrm>
                <a:off x="1295280" y="1515240"/>
                <a:ext cx="31464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1386360" y="1478160"/>
                <a:ext cx="100440" cy="69840"/>
              </a:xfrm>
              <a:prstGeom prst="diamond">
                <a:avLst/>
              </a:prstGeom>
              <a:solidFill>
                <a:srgbClr val="333399"/>
              </a:solidFill>
              <a:ln w="9360">
                <a:solidFill>
                  <a:srgbClr val="3333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520" bIns="-115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5" name=""/>
            <p:cNvGrpSpPr/>
            <p:nvPr/>
          </p:nvGrpSpPr>
          <p:grpSpPr>
            <a:xfrm>
              <a:off x="1295280" y="1647720"/>
              <a:ext cx="314640" cy="69840"/>
              <a:chOff x="1295280" y="1647720"/>
              <a:chExt cx="314640" cy="69840"/>
            </a:xfrm>
          </p:grpSpPr>
          <p:sp>
            <p:nvSpPr>
              <p:cNvPr id="56" name=""/>
              <p:cNvSpPr/>
              <p:nvPr/>
            </p:nvSpPr>
            <p:spPr>
              <a:xfrm>
                <a:off x="1295280" y="1678320"/>
                <a:ext cx="31464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V="1">
                <a:off x="1400400" y="1647720"/>
                <a:ext cx="91440" cy="69840"/>
              </a:xfrm>
              <a:prstGeom prst="rect">
                <a:avLst/>
              </a:prstGeom>
              <a:solidFill>
                <a:srgbClr val="ff3300"/>
              </a:solidFill>
              <a:ln w="936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3040" bIns="230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8" name=""/>
            <p:cNvGrpSpPr/>
            <p:nvPr/>
          </p:nvGrpSpPr>
          <p:grpSpPr>
            <a:xfrm>
              <a:off x="1295280" y="1820880"/>
              <a:ext cx="314640" cy="69840"/>
              <a:chOff x="1295280" y="1820880"/>
              <a:chExt cx="314640" cy="69840"/>
            </a:xfrm>
          </p:grpSpPr>
          <p:sp>
            <p:nvSpPr>
              <p:cNvPr id="59" name=""/>
              <p:cNvSpPr/>
              <p:nvPr/>
            </p:nvSpPr>
            <p:spPr>
              <a:xfrm flipH="1">
                <a:off x="1295280" y="1864440"/>
                <a:ext cx="314640" cy="0"/>
              </a:xfrm>
              <a:prstGeom prst="line">
                <a:avLst/>
              </a:prstGeom>
              <a:ln w="190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 rot="10800000">
                <a:off x="1404360" y="1820880"/>
                <a:ext cx="105120" cy="69840"/>
              </a:xfrm>
              <a:prstGeom prst="triangle">
                <a:avLst>
                  <a:gd name="adj" fmla="val 50000"/>
                </a:avLst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400" bIns="-234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" name=""/>
            <p:cNvSpPr/>
            <p:nvPr/>
          </p:nvSpPr>
          <p:spPr>
            <a:xfrm>
              <a:off x="1632240" y="1403280"/>
              <a:ext cx="1631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1.10.880.10.2 (Sfam cluster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638360" y="1573200"/>
              <a:ext cx="1473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.10.900.10 (S35 cluster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631520" y="1746360"/>
              <a:ext cx="1531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4.10.900.10 (S35 clusters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5T19:05:58Z</dcterms:created>
  <dc:creator>ucbcja0</dc:creator>
  <dc:description/>
  <dc:language>en-US</dc:language>
  <cp:lastModifiedBy>ucbcja0</cp:lastModifiedBy>
  <dcterms:modified xsi:type="dcterms:W3CDTF">2007-06-08T14:09:03Z</dcterms:modified>
  <cp:revision>16</cp:revision>
  <dc:subject/>
  <dc:title>Slide 1</dc:title>
</cp:coreProperties>
</file>